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image" Target="../media/image52.emf"/><Relationship Id="rId1" Type="http://schemas.openxmlformats.org/officeDocument/2006/relationships/image" Target="../media/image5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4" Type="http://schemas.openxmlformats.org/officeDocument/2006/relationships/image" Target="../media/image17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image" Target="../media/image26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0.wmf"/><Relationship Id="rId2" Type="http://schemas.openxmlformats.org/officeDocument/2006/relationships/image" Target="../media/image39.emf"/><Relationship Id="rId1" Type="http://schemas.openxmlformats.org/officeDocument/2006/relationships/image" Target="../media/image38.emf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7111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0312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609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91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3490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5080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9741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074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7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5087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5058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FF5BD-A5F3-4364-A95C-C5966DE9F35F}" type="datetimeFigureOut">
              <a:rPr lang="de-DE" smtClean="0"/>
              <a:t>18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24BC8-6395-4DC5-8A80-71EC53BD0E0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5790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emf"/><Relationship Id="rId3" Type="http://schemas.openxmlformats.org/officeDocument/2006/relationships/oleObject" Target="../embeddings/oleObject47.bin"/><Relationship Id="rId7" Type="http://schemas.openxmlformats.org/officeDocument/2006/relationships/oleObject" Target="../embeddings/oleObject4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52.emf"/><Relationship Id="rId5" Type="http://schemas.openxmlformats.org/officeDocument/2006/relationships/oleObject" Target="../embeddings/oleObject48.bin"/><Relationship Id="rId4" Type="http://schemas.openxmlformats.org/officeDocument/2006/relationships/image" Target="../media/image5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12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emf"/><Relationship Id="rId5" Type="http://schemas.openxmlformats.org/officeDocument/2006/relationships/oleObject" Target="../embeddings/oleObject15.bin"/><Relationship Id="rId10" Type="http://schemas.openxmlformats.org/officeDocument/2006/relationships/image" Target="../media/image17.emf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7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oleObject" Target="../embeddings/oleObject23.bin"/><Relationship Id="rId18" Type="http://schemas.openxmlformats.org/officeDocument/2006/relationships/image" Target="../media/image25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12" Type="http://schemas.openxmlformats.org/officeDocument/2006/relationships/image" Target="../media/image22.emf"/><Relationship Id="rId17" Type="http://schemas.openxmlformats.org/officeDocument/2006/relationships/oleObject" Target="../embeddings/oleObject2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9.emf"/><Relationship Id="rId11" Type="http://schemas.openxmlformats.org/officeDocument/2006/relationships/oleObject" Target="../embeddings/oleObject22.bin"/><Relationship Id="rId5" Type="http://schemas.openxmlformats.org/officeDocument/2006/relationships/oleObject" Target="../embeddings/oleObject19.bin"/><Relationship Id="rId15" Type="http://schemas.openxmlformats.org/officeDocument/2006/relationships/oleObject" Target="../embeddings/oleObject24.bin"/><Relationship Id="rId10" Type="http://schemas.openxmlformats.org/officeDocument/2006/relationships/image" Target="../media/image21.emf"/><Relationship Id="rId4" Type="http://schemas.openxmlformats.org/officeDocument/2006/relationships/image" Target="../media/image18.emf"/><Relationship Id="rId9" Type="http://schemas.openxmlformats.org/officeDocument/2006/relationships/oleObject" Target="../embeddings/oleObject21.bin"/><Relationship Id="rId14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oleObject" Target="../embeddings/oleObject26.bin"/><Relationship Id="rId7" Type="http://schemas.openxmlformats.org/officeDocument/2006/relationships/oleObject" Target="../embeddings/oleObject28.bin"/><Relationship Id="rId12" Type="http://schemas.openxmlformats.org/officeDocument/2006/relationships/image" Target="../media/image3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7.emf"/><Relationship Id="rId11" Type="http://schemas.openxmlformats.org/officeDocument/2006/relationships/oleObject" Target="../embeddings/oleObject30.bin"/><Relationship Id="rId5" Type="http://schemas.openxmlformats.org/officeDocument/2006/relationships/oleObject" Target="../embeddings/oleObject27.bin"/><Relationship Id="rId10" Type="http://schemas.openxmlformats.org/officeDocument/2006/relationships/image" Target="../media/image29.emf"/><Relationship Id="rId4" Type="http://schemas.openxmlformats.org/officeDocument/2006/relationships/image" Target="../media/image26.emf"/><Relationship Id="rId9" Type="http://schemas.openxmlformats.org/officeDocument/2006/relationships/oleObject" Target="../embeddings/oleObject29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13" Type="http://schemas.openxmlformats.org/officeDocument/2006/relationships/oleObject" Target="../embeddings/oleObject36.bin"/><Relationship Id="rId3" Type="http://schemas.openxmlformats.org/officeDocument/2006/relationships/oleObject" Target="../embeddings/oleObject31.bin"/><Relationship Id="rId7" Type="http://schemas.openxmlformats.org/officeDocument/2006/relationships/oleObject" Target="../embeddings/oleObject33.bin"/><Relationship Id="rId12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32.emf"/><Relationship Id="rId11" Type="http://schemas.openxmlformats.org/officeDocument/2006/relationships/oleObject" Target="../embeddings/oleObject35.bin"/><Relationship Id="rId5" Type="http://schemas.openxmlformats.org/officeDocument/2006/relationships/oleObject" Target="../embeddings/oleObject32.bin"/><Relationship Id="rId15" Type="http://schemas.openxmlformats.org/officeDocument/2006/relationships/oleObject" Target="../embeddings/oleObject37.bin"/><Relationship Id="rId10" Type="http://schemas.openxmlformats.org/officeDocument/2006/relationships/image" Target="../media/image34.emf"/><Relationship Id="rId4" Type="http://schemas.openxmlformats.org/officeDocument/2006/relationships/image" Target="../media/image31.emf"/><Relationship Id="rId9" Type="http://schemas.openxmlformats.org/officeDocument/2006/relationships/oleObject" Target="../embeddings/oleObject34.bin"/><Relationship Id="rId14" Type="http://schemas.openxmlformats.org/officeDocument/2006/relationships/image" Target="../media/image3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wmf"/><Relationship Id="rId3" Type="http://schemas.openxmlformats.org/officeDocument/2006/relationships/oleObject" Target="../embeddings/oleObject38.bin"/><Relationship Id="rId7" Type="http://schemas.openxmlformats.org/officeDocument/2006/relationships/oleObject" Target="../embeddings/oleObject40.bin"/><Relationship Id="rId12" Type="http://schemas.openxmlformats.org/officeDocument/2006/relationships/image" Target="../media/image4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9.emf"/><Relationship Id="rId11" Type="http://schemas.openxmlformats.org/officeDocument/2006/relationships/oleObject" Target="../embeddings/oleObject42.bin"/><Relationship Id="rId5" Type="http://schemas.openxmlformats.org/officeDocument/2006/relationships/oleObject" Target="../embeddings/oleObject39.bin"/><Relationship Id="rId10" Type="http://schemas.openxmlformats.org/officeDocument/2006/relationships/image" Target="../media/image41.emf"/><Relationship Id="rId4" Type="http://schemas.openxmlformats.org/officeDocument/2006/relationships/image" Target="../media/image38.emf"/><Relationship Id="rId9" Type="http://schemas.openxmlformats.org/officeDocument/2006/relationships/oleObject" Target="../embeddings/oleObject41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3" Type="http://schemas.openxmlformats.org/officeDocument/2006/relationships/oleObject" Target="../embeddings/oleObject43.bin"/><Relationship Id="rId7" Type="http://schemas.openxmlformats.org/officeDocument/2006/relationships/oleObject" Target="../embeddings/oleObject4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44.emf"/><Relationship Id="rId5" Type="http://schemas.openxmlformats.org/officeDocument/2006/relationships/oleObject" Target="../embeddings/oleObject44.bin"/><Relationship Id="rId4" Type="http://schemas.openxmlformats.org/officeDocument/2006/relationships/image" Target="../media/image43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emf"/><Relationship Id="rId3" Type="http://schemas.openxmlformats.org/officeDocument/2006/relationships/image" Target="../media/image47.png"/><Relationship Id="rId7" Type="http://schemas.openxmlformats.org/officeDocument/2006/relationships/oleObject" Target="../embeddings/oleObject4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324609" y="70236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317256" y="181645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313351" y="306732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26646" y="428858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7" name="Objekt 9">
            <a:extLst>
              <a:ext uri="{FF2B5EF4-FFF2-40B4-BE49-F238E27FC236}">
                <a16:creationId xmlns:a16="http://schemas.microsoft.com/office/drawing/2014/main" id="{000133F6-4FAD-0430-520F-D41FAC1521D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324610" y="795130"/>
          <a:ext cx="2173019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3997506" imgH="2652895" progId="Prism9.Document">
                  <p:embed/>
                </p:oleObj>
              </mc:Choice>
              <mc:Fallback>
                <p:oleObj name="Prism 9" r:id="rId3" imgW="3997506" imgH="2652895" progId="Prism9.Document">
                  <p:embed/>
                  <p:pic>
                    <p:nvPicPr>
                      <p:cNvPr id="17" name="Objekt 9">
                        <a:extLst>
                          <a:ext uri="{FF2B5EF4-FFF2-40B4-BE49-F238E27FC236}">
                            <a16:creationId xmlns:a16="http://schemas.microsoft.com/office/drawing/2014/main" id="{000133F6-4FAD-0430-520F-D41FAC1521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24610" y="795130"/>
                        <a:ext cx="2173019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20">
            <a:extLst>
              <a:ext uri="{FF2B5EF4-FFF2-40B4-BE49-F238E27FC236}">
                <a16:creationId xmlns:a16="http://schemas.microsoft.com/office/drawing/2014/main" id="{51EC249A-D03B-7CA6-D9CE-2A75D80AB10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335654" y="2025194"/>
          <a:ext cx="2165191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5" imgW="3965454" imgH="2634527" progId="Prism9.Document">
                  <p:embed/>
                </p:oleObj>
              </mc:Choice>
              <mc:Fallback>
                <p:oleObj name="Prism 9" r:id="rId5" imgW="3965454" imgH="2634527" progId="Prism9.Document">
                  <p:embed/>
                  <p:pic>
                    <p:nvPicPr>
                      <p:cNvPr id="18" name="Objekt 20">
                        <a:extLst>
                          <a:ext uri="{FF2B5EF4-FFF2-40B4-BE49-F238E27FC236}">
                            <a16:creationId xmlns:a16="http://schemas.microsoft.com/office/drawing/2014/main" id="{51EC249A-D03B-7CA6-D9CE-2A75D80AB1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35654" y="2025194"/>
                        <a:ext cx="2165191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21">
            <a:extLst>
              <a:ext uri="{FF2B5EF4-FFF2-40B4-BE49-F238E27FC236}">
                <a16:creationId xmlns:a16="http://schemas.microsoft.com/office/drawing/2014/main" id="{C92E881B-162F-AA81-0BF8-EF41829753C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337528" y="3221038"/>
          <a:ext cx="2181225" cy="1441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9" r:id="rId7" imgW="3983821" imgH="2630205" progId="Prism9.Document">
                  <p:embed/>
                </p:oleObj>
              </mc:Choice>
              <mc:Fallback>
                <p:oleObj name="Prism 9" r:id="rId7" imgW="3983821" imgH="2630205" progId="Prism9.Document">
                  <p:embed/>
                  <p:pic>
                    <p:nvPicPr>
                      <p:cNvPr id="19" name="Objekt 21">
                        <a:extLst>
                          <a:ext uri="{FF2B5EF4-FFF2-40B4-BE49-F238E27FC236}">
                            <a16:creationId xmlns:a16="http://schemas.microsoft.com/office/drawing/2014/main" id="{C92E881B-162F-AA81-0BF8-EF41829753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37528" y="3221038"/>
                        <a:ext cx="2181225" cy="1441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913266" y="5924943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1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2271379" y="4408936"/>
          <a:ext cx="221094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9" r:id="rId9" imgW="4065932" imgH="2648213" progId="Prism9.Document">
                  <p:embed/>
                </p:oleObj>
              </mc:Choice>
              <mc:Fallback>
                <p:oleObj name="Prism 9" r:id="rId9" imgW="4065932" imgH="2648213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71379" y="4408936"/>
                        <a:ext cx="221094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/>
          </p:cNvGraphicFramePr>
          <p:nvPr>
            <p:extLst/>
          </p:nvPr>
        </p:nvGraphicFramePr>
        <p:xfrm>
          <a:off x="4233002" y="4389438"/>
          <a:ext cx="2196000" cy="146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11" imgW="4065932" imgH="2648213" progId="Prism5.Document">
                  <p:embed/>
                </p:oleObj>
              </mc:Choice>
              <mc:Fallback>
                <p:oleObj name="Prism 5" r:id="rId11" imgW="4065932" imgH="2648213" progId="Prism5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33002" y="4389438"/>
                        <a:ext cx="2196000" cy="146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4252052" y="777876"/>
          <a:ext cx="2216150" cy="143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9" r:id="rId13" imgW="4020195" imgH="2611837" progId="Prism9.Document">
                  <p:embed/>
                </p:oleObj>
              </mc:Choice>
              <mc:Fallback>
                <p:oleObj name="Prism 9" r:id="rId13" imgW="4020195" imgH="2611837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52052" y="777876"/>
                        <a:ext cx="2216150" cy="143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4273011" y="2014033"/>
          <a:ext cx="2196000" cy="14623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9" r:id="rId15" imgW="3983821" imgH="2652895" progId="Prism9.Document">
                  <p:embed/>
                </p:oleObj>
              </mc:Choice>
              <mc:Fallback>
                <p:oleObj name="Prism 9" r:id="rId15" imgW="3983821" imgH="2652895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273011" y="2014033"/>
                        <a:ext cx="2196000" cy="14623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/>
          </p:cNvGraphicFramePr>
          <p:nvPr>
            <p:extLst/>
          </p:nvPr>
        </p:nvGraphicFramePr>
        <p:xfrm>
          <a:off x="4302851" y="3225799"/>
          <a:ext cx="2196000" cy="146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9" r:id="rId17" imgW="3928721" imgH="2648213" progId="Prism9.Document">
                  <p:embed/>
                </p:oleObj>
              </mc:Choice>
              <mc:Fallback>
                <p:oleObj name="Prism 9" r:id="rId17" imgW="3928721" imgH="2648213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302851" y="3225799"/>
                        <a:ext cx="2196000" cy="146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tangle 11"/>
          <p:cNvSpPr/>
          <p:nvPr/>
        </p:nvSpPr>
        <p:spPr>
          <a:xfrm>
            <a:off x="6344767" y="1593626"/>
            <a:ext cx="355011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1.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me- and concentration-dependent activation of </a:t>
            </a:r>
            <a:r>
              <a:rPr lang="en-US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ptosis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</a:t>
            </a:r>
            <a:r>
              <a:rPr lang="en-US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SL-3 in the LUHMES model.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HMES were pre-differentiated for 2 days to ensure termination of proliferation and were then seeded at a density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40,000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t day 6 of differentiation, the cells were exposed to various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RSL-3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centrations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the time intervals as indicated. Viability was assessed by the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azur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duction assay,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LDH release assay, and by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detection of total intracellular glutathione (reduced and oxidized).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quantitativ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eurite mass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tection,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cells were fixed and subjected to an automated, label-free microscopic analysis. Neurite mass is determined as fraction of neurite-covered area / cell-covered area (neurites / neurites +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mata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± SD of biological triplicates. Each biological replicate includ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echnical replicates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ifferences were tested for significance by one-way ANOVA, followed by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 hoc test. *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&lt; 0.05 for comparison with untreated controls. Statistical analysis was performed using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Software, La Jolla, US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57519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1774229" y="1525042"/>
          <a:ext cx="2971800" cy="3173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2" name="Prism 5" r:id="rId3" imgW="2971800" imgH="3172680" progId="Prism5.Document">
                  <p:embed/>
                </p:oleObj>
              </mc:Choice>
              <mc:Fallback>
                <p:oleObj name="Prism 5" r:id="rId3" imgW="2971800" imgH="317268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4229" y="1525042"/>
                        <a:ext cx="2971800" cy="3173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4115475" y="1525042"/>
          <a:ext cx="2898775" cy="3173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3" name="Prism 5" r:id="rId5" imgW="2898720" imgH="3172680" progId="Prism5.Document">
                  <p:embed/>
                </p:oleObj>
              </mc:Choice>
              <mc:Fallback>
                <p:oleObj name="Prism 5" r:id="rId5" imgW="2898720" imgH="3172680" progId="Prism5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15475" y="1525042"/>
                        <a:ext cx="2898775" cy="3173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6690045" y="1523132"/>
          <a:ext cx="2862263" cy="3173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4" name="Prism 5" r:id="rId7" imgW="2862000" imgH="3172680" progId="Prism5.Document">
                  <p:embed/>
                </p:oleObj>
              </mc:Choice>
              <mc:Fallback>
                <p:oleObj name="Prism 5" r:id="rId7" imgW="2862000" imgH="317268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90045" y="1523132"/>
                        <a:ext cx="2862263" cy="3173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342516" y="4990825"/>
            <a:ext cx="3121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10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7920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6284115" y="844680"/>
          <a:ext cx="1884669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9" r:id="rId3" imgW="3226096" imgH="2648213" progId="Prism9.Document">
                  <p:embed/>
                </p:oleObj>
              </mc:Choice>
              <mc:Fallback>
                <p:oleObj name="Prism 9" r:id="rId3" imgW="3226096" imgH="264821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84115" y="844680"/>
                        <a:ext cx="1884669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5161161" y="850381"/>
          <a:ext cx="1414221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5" r:id="rId5" imgW="2421192" imgH="2648213" progId="Prism5.Document">
                  <p:embed/>
                </p:oleObj>
              </mc:Choice>
              <mc:Fallback>
                <p:oleObj name="Prism 5" r:id="rId5" imgW="2421192" imgH="2648213" progId="Prism5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61161" y="850381"/>
                        <a:ext cx="1414221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805720" y="850049"/>
          <a:ext cx="1676076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9" r:id="rId7" imgW="2866320" imgH="2648213" progId="Prism9.Document">
                  <p:embed/>
                </p:oleObj>
              </mc:Choice>
              <mc:Fallback>
                <p:oleObj name="Prism 9" r:id="rId7" imgW="2866320" imgH="2648213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05720" y="850049"/>
                        <a:ext cx="1676076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797459" y="2294899"/>
          <a:ext cx="2228084" cy="147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9" r:id="rId9" imgW="4000388" imgH="2648213" progId="Prism9.Document">
                  <p:embed/>
                </p:oleObj>
              </mc:Choice>
              <mc:Fallback>
                <p:oleObj name="Prism 9" r:id="rId9" imgW="4000388" imgH="2648213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97459" y="2294899"/>
                        <a:ext cx="2228084" cy="147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5944323" y="2232369"/>
          <a:ext cx="1963738" cy="1522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9" r:id="rId11" imgW="3482152" imgH="2698634" progId="Prism9.Document">
                  <p:embed/>
                </p:oleObj>
              </mc:Choice>
              <mc:Fallback>
                <p:oleObj name="Prism 9" r:id="rId11" imgW="3482152" imgH="2698634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944323" y="2232369"/>
                        <a:ext cx="1963738" cy="1522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797459" y="672520"/>
            <a:ext cx="262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97458" y="204345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692581" y="22575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548313" y="6954454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2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4231119" y="3869857"/>
            <a:ext cx="3550111" cy="27135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2.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HMES at day 6 of differentiation were treated with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24 h) or RSL-3 (18 h) at different concentrations, respectively with a single concentration of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1 µM) or RSL-3 (25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for different time intervals. Total intracellular content of ATP was detected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hanges in mitochondrial respiration upon treatment with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1 µM) for various time intervals were analysed by the detection of the oxygen consumption rate (OCR)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is OCR was detected in LUHMES exposed to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1 µM) in the presence or absence of coenzyme Q</a:t>
            </a:r>
            <a:r>
              <a:rPr lang="en-GB" sz="9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OCR was normalized to the cell number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data are means ± SD of biological triplicates with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 (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respectively 8 (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chnical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licate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s were tested for significance by one-way 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 for comparison with untreated controls. Statistical analysis was performed using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oftware, La Jolla, USA).</a:t>
            </a:r>
          </a:p>
          <a:p>
            <a:pPr algn="just">
              <a:spcAft>
                <a:spcPts val="1000"/>
              </a:spcAft>
            </a:pPr>
            <a:endParaRPr lang="en-US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4352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/>
          </p:cNvGraphicFramePr>
          <p:nvPr>
            <p:extLst/>
          </p:nvPr>
        </p:nvGraphicFramePr>
        <p:xfrm>
          <a:off x="3460751" y="244476"/>
          <a:ext cx="287337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9" r:id="rId3" imgW="4003629" imgH="2430319" progId="Prism9.Document">
                  <p:embed/>
                </p:oleObj>
              </mc:Choice>
              <mc:Fallback>
                <p:oleObj name="Prism 9" r:id="rId3" imgW="4003629" imgH="2430319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60751" y="244476"/>
                        <a:ext cx="287337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/>
          </p:cNvGraphicFramePr>
          <p:nvPr>
            <p:extLst/>
          </p:nvPr>
        </p:nvGraphicFramePr>
        <p:xfrm>
          <a:off x="5865814" y="238126"/>
          <a:ext cx="287337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9" r:id="rId5" imgW="4003629" imgH="2430319" progId="Prism9.Document">
                  <p:embed/>
                </p:oleObj>
              </mc:Choice>
              <mc:Fallback>
                <p:oleObj name="Prism 9" r:id="rId5" imgW="4003629" imgH="2430319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65814" y="238126"/>
                        <a:ext cx="287337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/>
          </p:cNvGraphicFramePr>
          <p:nvPr>
            <p:extLst/>
          </p:nvPr>
        </p:nvGraphicFramePr>
        <p:xfrm>
          <a:off x="3519488" y="1803401"/>
          <a:ext cx="2876550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9" r:id="rId7" imgW="3942406" imgH="2681707" progId="Prism9.Document">
                  <p:embed/>
                </p:oleObj>
              </mc:Choice>
              <mc:Fallback>
                <p:oleObj name="Prism 9" r:id="rId7" imgW="3942406" imgH="2681707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19488" y="1803401"/>
                        <a:ext cx="2876550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/>
          </p:cNvGraphicFramePr>
          <p:nvPr>
            <p:extLst/>
          </p:nvPr>
        </p:nvGraphicFramePr>
        <p:xfrm>
          <a:off x="5927726" y="1835150"/>
          <a:ext cx="2874963" cy="180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9" r:id="rId9" imgW="3942406" imgH="2430319" progId="Prism9.Document">
                  <p:embed/>
                </p:oleObj>
              </mc:Choice>
              <mc:Fallback>
                <p:oleObj name="Prism 9" r:id="rId9" imgW="3942406" imgH="2430319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927726" y="1835150"/>
                        <a:ext cx="2874963" cy="180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682703" y="5234745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3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158095" y="3664615"/>
            <a:ext cx="386947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 </a:t>
            </a: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ell density-dependent activation of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erroptotic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cell death.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fter a 2-day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redifferentiation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eriod, LUHMES cells were seeded at a density of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0,000 cells/well or 45,000 cells/well (= 300,000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r 150,000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t day 6 of differentiation, the cells were treat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erastin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24 h, 0.75 µM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SL-3 (18 h, 25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. For the detection of cell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tegrity, LDH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lease, and intracellular glutathione concentration were determined. Data are presented as mean ± SD of biological triplicates. Differences were tested for significance by one-way ANOVA, followed by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 hoc test. *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&lt; 0.05 for comparison with untreated control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16392" y="245661"/>
            <a:ext cx="29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827508" y="2438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7516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095789" y="231633"/>
          <a:ext cx="2233613" cy="179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9" r:id="rId3" imgW="3290200" imgH="2648213" progId="Prism9.Document">
                  <p:embed/>
                </p:oleObj>
              </mc:Choice>
              <mc:Fallback>
                <p:oleObj name="Prism 9" r:id="rId3" imgW="3290200" imgH="264821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95789" y="231633"/>
                        <a:ext cx="2233613" cy="179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/>
          </p:cNvGraphicFramePr>
          <p:nvPr>
            <p:extLst/>
          </p:nvPr>
        </p:nvGraphicFramePr>
        <p:xfrm>
          <a:off x="4180106" y="229939"/>
          <a:ext cx="216000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9" r:id="rId5" imgW="3227536" imgH="2654335" progId="Prism9.Document">
                  <p:embed/>
                </p:oleObj>
              </mc:Choice>
              <mc:Fallback>
                <p:oleObj name="Prism 9" r:id="rId5" imgW="3227536" imgH="2654335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80106" y="229939"/>
                        <a:ext cx="216000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/>
          </p:cNvGraphicFramePr>
          <p:nvPr>
            <p:extLst/>
          </p:nvPr>
        </p:nvGraphicFramePr>
        <p:xfrm>
          <a:off x="2103726" y="1769920"/>
          <a:ext cx="2233612" cy="179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9" r:id="rId7" imgW="3290200" imgH="2822167" progId="Prism9.Document">
                  <p:embed/>
                </p:oleObj>
              </mc:Choice>
              <mc:Fallback>
                <p:oleObj name="Prism 9" r:id="rId7" imgW="3290200" imgH="2822167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03726" y="1769920"/>
                        <a:ext cx="2233612" cy="179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/>
          </p:cNvGraphicFramePr>
          <p:nvPr>
            <p:extLst/>
          </p:nvPr>
        </p:nvGraphicFramePr>
        <p:xfrm>
          <a:off x="4180106" y="1733571"/>
          <a:ext cx="216000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9" r:id="rId9" imgW="3226096" imgH="2822167" progId="Prism9.Document">
                  <p:embed/>
                </p:oleObj>
              </mc:Choice>
              <mc:Fallback>
                <p:oleObj name="Prism 9" r:id="rId9" imgW="3226096" imgH="2822167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180106" y="1733571"/>
                        <a:ext cx="216000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100697" y="124358"/>
            <a:ext cx="382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120140" y="164822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17164" y="6371843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4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ject 11"/>
          <p:cNvGraphicFramePr>
            <a:graphicFrameLocks/>
          </p:cNvGraphicFramePr>
          <p:nvPr>
            <p:extLst/>
          </p:nvPr>
        </p:nvGraphicFramePr>
        <p:xfrm>
          <a:off x="2091414" y="3227246"/>
          <a:ext cx="2332037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9" r:id="rId11" imgW="3373751" imgH="2648213" progId="Prism9.Document">
                  <p:embed/>
                </p:oleObj>
              </mc:Choice>
              <mc:Fallback>
                <p:oleObj name="Prism 9" r:id="rId11" imgW="3373751" imgH="2648213" progId="Prism9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091414" y="3227246"/>
                        <a:ext cx="2332037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/>
          </p:cNvGraphicFramePr>
          <p:nvPr>
            <p:extLst/>
          </p:nvPr>
        </p:nvGraphicFramePr>
        <p:xfrm>
          <a:off x="4149725" y="3243263"/>
          <a:ext cx="2336800" cy="1801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9" r:id="rId13" imgW="3319011" imgH="2691071" progId="Prism9.Document">
                  <p:embed/>
                </p:oleObj>
              </mc:Choice>
              <mc:Fallback>
                <p:oleObj name="Prism 9" r:id="rId13" imgW="3319011" imgH="2691071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149725" y="3243263"/>
                        <a:ext cx="2336800" cy="1801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2118925" y="31246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2098340" y="4763436"/>
          <a:ext cx="230400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4" name="Prism 9" r:id="rId15" imgW="3290200" imgH="2822167" progId="Prism9.Document">
                  <p:embed/>
                </p:oleObj>
              </mc:Choice>
              <mc:Fallback>
                <p:oleObj name="Prism 9" r:id="rId15" imgW="3290200" imgH="2822167" progId="Prism9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98340" y="4763436"/>
                        <a:ext cx="230400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/>
          </p:nvPr>
        </p:nvGraphicFramePr>
        <p:xfrm>
          <a:off x="4128887" y="4748888"/>
          <a:ext cx="230400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9" r:id="rId17" imgW="3290200" imgH="2822167" progId="Prism9.Document">
                  <p:embed/>
                </p:oleObj>
              </mc:Choice>
              <mc:Fallback>
                <p:oleObj name="Prism 9" r:id="rId17" imgW="3290200" imgH="2822167" progId="Prism9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128887" y="4748888"/>
                        <a:ext cx="230400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2131089" y="4639142"/>
            <a:ext cx="382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Rectangle 6"/>
          <p:cNvSpPr/>
          <p:nvPr/>
        </p:nvSpPr>
        <p:spPr>
          <a:xfrm>
            <a:off x="6413719" y="2478347"/>
            <a:ext cx="3869475" cy="24468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 4.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ptosis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 in proliferating LUHMES.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liferating LUHMES (doubling time ca. 18 h) were seeded at a density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,000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fter one day, the cells were treated with varying concentrations of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st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24 h), respectively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SL-3 (18 h).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+D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comparison with other cell models, the human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atoma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ine HepG2 and the mouse macrophage-like cell lin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774A.1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re employed. HepG2 (doubling time ca. 48 h) were seeded at a density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20,000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774A.1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oubling time ca. 24 h) were seeded at a density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0,000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were allowed to grow for 2 days. The cells were the exposed to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st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RSL-3 for 24 h and were analyzed for impaired viability by the detection of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azur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duction. Data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 means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D of biological triplicates. Each biological replicate included 6 technical replicates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s were tested for significance by one-way 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 for comparison with untreated controls. Statistical analysis was performed using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oftware, La Jolla, USA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0463877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622968" y="2179006"/>
          <a:ext cx="2714535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9" r:id="rId3" imgW="3992825" imgH="2648213" progId="Prism9.Document">
                  <p:embed/>
                </p:oleObj>
              </mc:Choice>
              <mc:Fallback>
                <p:oleObj name="Prism 9" r:id="rId3" imgW="3992825" imgH="264821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22968" y="2179006"/>
                        <a:ext cx="2714535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5279241" y="2179006"/>
          <a:ext cx="220792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9" r:id="rId5" imgW="3248784" imgH="2648213" progId="Prism9.Document">
                  <p:embed/>
                </p:oleObj>
              </mc:Choice>
              <mc:Fallback>
                <p:oleObj name="Prism 9" r:id="rId5" imgW="3248784" imgH="2648213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79241" y="2179006"/>
                        <a:ext cx="220792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7227469" y="2179006"/>
          <a:ext cx="220792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9" r:id="rId7" imgW="3248784" imgH="2648213" progId="Prism9.Document">
                  <p:embed/>
                </p:oleObj>
              </mc:Choice>
              <mc:Fallback>
                <p:oleObj name="Prism 9" r:id="rId7" imgW="3248784" imgH="2648213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27469" y="2179006"/>
                        <a:ext cx="220792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9">
            <a:extLst>
              <a:ext uri="{FF2B5EF4-FFF2-40B4-BE49-F238E27FC236}">
                <a16:creationId xmlns:a16="http://schemas.microsoft.com/office/drawing/2014/main" id="{B36D818C-0F6C-C734-32F1-30C4622BEB9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649419" y="332491"/>
          <a:ext cx="2924048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5" r:id="rId9" imgW="4090320" imgH="2770560" progId="Prism5.Document">
                  <p:embed/>
                </p:oleObj>
              </mc:Choice>
              <mc:Fallback>
                <p:oleObj name="Prism 5" r:id="rId9" imgW="4090320" imgH="2770560" progId="Prism5.Document">
                  <p:embed/>
                  <p:pic>
                    <p:nvPicPr>
                      <p:cNvPr id="6" name="Objekt 9">
                        <a:extLst>
                          <a:ext uri="{FF2B5EF4-FFF2-40B4-BE49-F238E27FC236}">
                            <a16:creationId xmlns:a16="http://schemas.microsoft.com/office/drawing/2014/main" id="{B36D818C-0F6C-C734-32F1-30C4622BEB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649419" y="332491"/>
                        <a:ext cx="2924048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2">
            <a:extLst>
              <a:ext uri="{FF2B5EF4-FFF2-40B4-BE49-F238E27FC236}">
                <a16:creationId xmlns:a16="http://schemas.microsoft.com/office/drawing/2014/main" id="{0A586CA2-7EFF-DB32-318B-44C0D16E79E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622967" y="332491"/>
          <a:ext cx="2937512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5" r:id="rId11" imgW="4090680" imgH="2756880" progId="Prism5.Document">
                  <p:embed/>
                </p:oleObj>
              </mc:Choice>
              <mc:Fallback>
                <p:oleObj name="Prism 5" r:id="rId11" imgW="4090680" imgH="2756880" progId="Prism5.Document">
                  <p:embed/>
                  <p:pic>
                    <p:nvPicPr>
                      <p:cNvPr id="7" name="Objekt 2">
                        <a:extLst>
                          <a:ext uri="{FF2B5EF4-FFF2-40B4-BE49-F238E27FC236}">
                            <a16:creationId xmlns:a16="http://schemas.microsoft.com/office/drawing/2014/main" id="{0A586CA2-7EFF-DB32-318B-44C0D16E79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622967" y="332491"/>
                        <a:ext cx="2937512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71459" y="1182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78774" y="198198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41604" y="198198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992047" y="5502356"/>
            <a:ext cx="16081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5. </a:t>
            </a:r>
          </a:p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091724" y="3961988"/>
            <a:ext cx="3550111" cy="27238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5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HMES were differentiated as monoculture (240,000 cells/cm</a:t>
            </a:r>
            <a:r>
              <a:rPr lang="en-GB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treated with cysteine or GSH for 24 h. Following several washing steps, the intracellular content of glutathione was assessed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UHMES were exposed to RSL-3 in the presence of various concentrations of GSH for 18 h. Viability was then assessed by the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azur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duction and the LDH release assays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UHMES were either differentiated as monocultures (240,000 cells/cm</a:t>
            </a:r>
            <a:r>
              <a:rPr lang="en-GB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at a ratio of 90% LUHMES and 10% astrocytes. At day 6 of differentiation, cells were exposed to RSL-3 (18 h), intracellular levels of glutathione or ATP were analysed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are presented as mean ± SD of biological triplicates. Each biological replicate included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chnical replicates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s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in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ed for significance by one-way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 hoc test, respectively by two-way ANOVA (in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nferroni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 &lt; 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.05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 analysis was performed using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oftware, La Jolla, USA).</a:t>
            </a:r>
          </a:p>
        </p:txBody>
      </p:sp>
    </p:spTree>
    <p:extLst>
      <p:ext uri="{BB962C8B-B14F-4D97-AF65-F5344CB8AC3E}">
        <p14:creationId xmlns:p14="http://schemas.microsoft.com/office/powerpoint/2010/main" val="27252921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163474" y="26528"/>
          <a:ext cx="3121326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9" r:id="rId3" imgW="4572283" imgH="3163593" progId="Prism9.Document">
                  <p:embed/>
                </p:oleObj>
              </mc:Choice>
              <mc:Fallback>
                <p:oleObj name="Prism 9" r:id="rId3" imgW="4572283" imgH="316359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63474" y="26528"/>
                        <a:ext cx="3121326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4860488" y="127"/>
          <a:ext cx="3135824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9" r:id="rId5" imgW="4683565" imgH="3226260" progId="Prism9.Document">
                  <p:embed/>
                </p:oleObj>
              </mc:Choice>
              <mc:Fallback>
                <p:oleObj name="Prism 9" r:id="rId5" imgW="4683565" imgH="3226260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60488" y="127"/>
                        <a:ext cx="3135824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4926664" y="1734649"/>
          <a:ext cx="2941322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9" r:id="rId7" imgW="4314426" imgH="3168275" progId="Prism9.Document">
                  <p:embed/>
                </p:oleObj>
              </mc:Choice>
              <mc:Fallback>
                <p:oleObj name="Prism 9" r:id="rId7" imgW="4314426" imgH="3168275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926664" y="1734649"/>
                        <a:ext cx="2941322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2216689" y="3363146"/>
          <a:ext cx="2952210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9" r:id="rId9" imgW="4413823" imgH="3229141" progId="Prism9.Document">
                  <p:embed/>
                </p:oleObj>
              </mc:Choice>
              <mc:Fallback>
                <p:oleObj name="Prism 9" r:id="rId9" imgW="4413823" imgH="3229141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16689" y="3363146"/>
                        <a:ext cx="2952210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177895" y="8401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177895" y="171657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02844" y="6269976"/>
            <a:ext cx="3048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6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804877" y="960183"/>
            <a:ext cx="2028487" cy="46628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6.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fluence of iron on </a:t>
            </a:r>
            <a:r>
              <a:rPr lang="en-GB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ptosis</a:t>
            </a: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ation.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HMES were differentiated for 2 days in regular medium and were then seeded either in regular iron-containing differentiation medium (iron (+)), or in medium devoid (iron (-)) of the iron components in the medium. After 4 additional days of differentiation (i.e., a total of 6 days), the cells were treated with different concentrations of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astin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24 h) or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SL-3 (18 h). Viability as well as intracellular ATP and glutathione were determined. </a:t>
            </a:r>
            <a:r>
              <a:rPr lang="en-GB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pid peroxidation of RSL-3 exposed cells, differentiated in the presence (+) or absence (-) of iron was determined by the fluorescent probe sensor BODIPY</a:t>
            </a:r>
            <a:r>
              <a:rPr lang="en-GB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M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81/591 C11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are presented as mean ± SD of biological triplicates. Each biological replicate included 6 technical replicates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s were tested for significance by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wo-way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nferroni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.05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 analysis was performed using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oftware, La Jolla, USA).</a:t>
            </a:r>
            <a:endParaRPr lang="de-DE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ct 13"/>
          <p:cNvGraphicFramePr>
            <a:graphicFrameLocks/>
          </p:cNvGraphicFramePr>
          <p:nvPr>
            <p:extLst/>
          </p:nvPr>
        </p:nvGraphicFramePr>
        <p:xfrm>
          <a:off x="2163475" y="1768607"/>
          <a:ext cx="299994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9" r:id="rId11" imgW="4473246" imgH="3221578" progId="Prism9.Document">
                  <p:embed/>
                </p:oleObj>
              </mc:Choice>
              <mc:Fallback>
                <p:oleObj name="Prism 9" r:id="rId11" imgW="4473246" imgH="3221578" progId="Prism9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63475" y="1768607"/>
                        <a:ext cx="299994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4921877" y="3332918"/>
          <a:ext cx="2953666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1" name="Prism 9" r:id="rId13" imgW="4413823" imgH="3227701" progId="Prism9.Document">
                  <p:embed/>
                </p:oleObj>
              </mc:Choice>
              <mc:Fallback>
                <p:oleObj name="Prism 9" r:id="rId13" imgW="4413823" imgH="3227701" progId="Prism9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921877" y="3332918"/>
                        <a:ext cx="2953666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/>
          </p:nvPr>
        </p:nvGraphicFramePr>
        <p:xfrm>
          <a:off x="2308226" y="4999039"/>
          <a:ext cx="2874963" cy="1944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2" name="Prism 9" r:id="rId15" imgW="3942406" imgH="2666581" progId="Prism9.Document">
                  <p:embed/>
                </p:oleObj>
              </mc:Choice>
              <mc:Fallback>
                <p:oleObj name="Prism 9" r:id="rId15" imgW="3942406" imgH="2666581" progId="Prism9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308226" y="4999039"/>
                        <a:ext cx="2874963" cy="1944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2171031" y="488889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428476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430856" y="2263670"/>
          <a:ext cx="2971430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9" r:id="rId3" imgW="3608560" imgH="2648213" progId="Prism9.Document">
                  <p:embed/>
                </p:oleObj>
              </mc:Choice>
              <mc:Fallback>
                <p:oleObj name="Prism 9" r:id="rId3" imgW="3608560" imgH="264821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30856" y="2263670"/>
                        <a:ext cx="2971430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5415582" y="2269092"/>
          <a:ext cx="2971430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9" r:id="rId5" imgW="3631609" imgH="2648213" progId="Prism9.Document">
                  <p:embed/>
                </p:oleObj>
              </mc:Choice>
              <mc:Fallback>
                <p:oleObj name="Prism 9" r:id="rId5" imgW="3631609" imgH="2648213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15582" y="2269092"/>
                        <a:ext cx="2971430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7525384" y="392527"/>
          <a:ext cx="2414173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2" name="Prism 5" r:id="rId7" imgW="3224520" imgH="2647080" progId="Prism5.Document">
                  <p:embed/>
                </p:oleObj>
              </mc:Choice>
              <mc:Fallback>
                <p:oleObj name="Prism 5" r:id="rId7" imgW="3224520" imgH="264708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25384" y="392527"/>
                        <a:ext cx="2414173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318476" y="6488668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7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453848" y="26737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46358" y="2152641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826848" y="4496915"/>
            <a:ext cx="4572000" cy="161582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7.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dulation of intracellular iron levels influences </a:t>
            </a:r>
            <a:r>
              <a:rPr lang="en-US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ptosis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.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UHMES were pre-differentiated for 2 days in regular, iron-containing medium. The cells were then passaged and seeded at a cell density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40,000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/cm</a:t>
            </a:r>
            <a:r>
              <a:rPr lang="en-US" sz="9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edium containing different percentage shares of total iron supply present in regular Advanced DMEM/F12 medium (ferric nitrate 0.05 mg/l; ferric sulfate 0.417 mg/l; human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lo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ransferrin 7.5 mg/l). At day 6 of differentiation, the cells were exposed to RSL-3 (25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for a period of 18 h and analyzed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cell viability, glutathione and ATP.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fluenc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oferrit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, respectively ferritin L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ptosi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fter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 18 h incubation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iod with RSL-3 (25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ular viability was analyzed. Differences were tested for significance by one-way 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 for comparison with untreated controls.</a:t>
            </a:r>
            <a:endParaRPr lang="de-DE" sz="9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/>
          </p:nvPr>
        </p:nvGraphicFramePr>
        <p:xfrm>
          <a:off x="2453848" y="405019"/>
          <a:ext cx="2928938" cy="1979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9" r:id="rId9" imgW="3919717" imgH="2648213" progId="Prism9.Document">
                  <p:embed/>
                </p:oleObj>
              </mc:Choice>
              <mc:Fallback>
                <p:oleObj name="Prism 9" r:id="rId9" imgW="3919717" imgH="2648213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53848" y="405019"/>
                        <a:ext cx="2928938" cy="1979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/>
          </p:nvPr>
        </p:nvGraphicFramePr>
        <p:xfrm>
          <a:off x="5328542" y="404219"/>
          <a:ext cx="2414588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4" name="Prism 5" r:id="rId11" imgW="3226096" imgH="2648213" progId="Prism5.Document">
                  <p:embed/>
                </p:oleObj>
              </mc:Choice>
              <mc:Fallback>
                <p:oleObj name="Prism 5" r:id="rId11" imgW="3226096" imgH="2648213" progId="Prism5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28542" y="404219"/>
                        <a:ext cx="2414588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262873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6">
            <a:extLst>
              <a:ext uri="{FF2B5EF4-FFF2-40B4-BE49-F238E27FC236}">
                <a16:creationId xmlns:a16="http://schemas.microsoft.com/office/drawing/2014/main" id="{E6B5C60A-7BF8-05BF-FA94-28513F44D4B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25738" y="579014"/>
          <a:ext cx="3719077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4" name="Prism 9" r:id="rId3" imgW="4110229" imgH="2785431" progId="Prism9.Document">
                  <p:embed/>
                </p:oleObj>
              </mc:Choice>
              <mc:Fallback>
                <p:oleObj name="Prism 9" r:id="rId3" imgW="4110229" imgH="2785431" progId="Prism9.Document">
                  <p:embed/>
                  <p:pic>
                    <p:nvPicPr>
                      <p:cNvPr id="2" name="Objekt 6">
                        <a:extLst>
                          <a:ext uri="{FF2B5EF4-FFF2-40B4-BE49-F238E27FC236}">
                            <a16:creationId xmlns:a16="http://schemas.microsoft.com/office/drawing/2014/main" id="{E6B5C60A-7BF8-05BF-FA94-28513F44D4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25738" y="579014"/>
                        <a:ext cx="3719077" cy="25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3">
            <a:extLst>
              <a:ext uri="{FF2B5EF4-FFF2-40B4-BE49-F238E27FC236}">
                <a16:creationId xmlns:a16="http://schemas.microsoft.com/office/drawing/2014/main" id="{4A852601-DCD2-CFCF-BF45-CD9E817ABFB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867234" y="579014"/>
          <a:ext cx="3709415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5" name="Prism 9" r:id="rId5" imgW="4110229" imgH="2790113" progId="Prism9.Document">
                  <p:embed/>
                </p:oleObj>
              </mc:Choice>
              <mc:Fallback>
                <p:oleObj name="Prism 9" r:id="rId5" imgW="4110229" imgH="2790113" progId="Prism9.Document">
                  <p:embed/>
                  <p:pic>
                    <p:nvPicPr>
                      <p:cNvPr id="3" name="Objekt 3">
                        <a:extLst>
                          <a:ext uri="{FF2B5EF4-FFF2-40B4-BE49-F238E27FC236}">
                            <a16:creationId xmlns:a16="http://schemas.microsoft.com/office/drawing/2014/main" id="{4A852601-DCD2-CFCF-BF45-CD9E817ABF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67234" y="579014"/>
                        <a:ext cx="3709415" cy="25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687761" y="6159826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8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5">
            <a:extLst>
              <a:ext uri="{FF2B5EF4-FFF2-40B4-BE49-F238E27FC236}">
                <a16:creationId xmlns:a16="http://schemas.microsoft.com/office/drawing/2014/main" id="{DBB0CAD5-32E7-A21C-2F8B-CB488B6D704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687760" y="2965752"/>
          <a:ext cx="3532932" cy="25645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6" name="Prism 5" r:id="rId7" imgW="3850931" imgH="2794795" progId="Prism5.Document">
                  <p:embed/>
                </p:oleObj>
              </mc:Choice>
              <mc:Fallback>
                <p:oleObj name="Prism 5" r:id="rId7" imgW="3850931" imgH="2794795" progId="Prism5.Document">
                  <p:embed/>
                  <p:pic>
                    <p:nvPicPr>
                      <p:cNvPr id="5" name="Objekt 5">
                        <a:extLst>
                          <a:ext uri="{FF2B5EF4-FFF2-40B4-BE49-F238E27FC236}">
                            <a16:creationId xmlns:a16="http://schemas.microsoft.com/office/drawing/2014/main" id="{DBB0CAD5-32E7-A21C-2F8B-CB488B6D70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87760" y="2965752"/>
                        <a:ext cx="3532932" cy="25645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6395477" y="3094969"/>
            <a:ext cx="3006387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. 8.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admium-</a:t>
            </a:r>
            <a:r>
              <a:rPr lang="de-DE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lation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tential </a:t>
            </a:r>
            <a:r>
              <a:rPr lang="de-DE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feroxamine</a:t>
            </a:r>
            <a:r>
              <a:rPr lang="de-DE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UHMES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re treated with different concentrations of cadmium in the presence and absence of the iron-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lator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feroxamine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FO) for 24 h. Viability was assessed by the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azurin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by the LDH release assays. </a:t>
            </a:r>
            <a:r>
              <a:rPr lang="en-US" sz="9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 investigate the detection of free and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lator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bound iron by the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zine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say employed in this work, a calibration curve of FeCl</a:t>
            </a:r>
            <a:r>
              <a:rPr lang="en-US" sz="9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s prepared in the presence and absence of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feroxamine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100 µM) and subjected to analysis by the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ozine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based iron detection assay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are presented as mean ± SD of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 biological replicate, including 8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chnical replicates. The normal distribution of the data was assessed using the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iro-Wilk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t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s were tested for significance by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wo-way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OVA, followed by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nferroni’s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 hoc test. *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.05.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 analysis was performed using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5.0 (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oftware, La Jolla, USA).</a:t>
            </a:r>
            <a:endParaRPr lang="de-DE" sz="9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77721" y="438866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485278" y="2864137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91657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26" r="20762"/>
          <a:stretch/>
        </p:blipFill>
        <p:spPr>
          <a:xfrm>
            <a:off x="4700824" y="780750"/>
            <a:ext cx="2791635" cy="34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78" r="20407"/>
          <a:stretch/>
        </p:blipFill>
        <p:spPr>
          <a:xfrm>
            <a:off x="7620530" y="773316"/>
            <a:ext cx="2794125" cy="342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30" r="20414"/>
          <a:stretch/>
        </p:blipFill>
        <p:spPr>
          <a:xfrm>
            <a:off x="1845651" y="780750"/>
            <a:ext cx="2778228" cy="342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707" t="45881" r="773" b="43581"/>
          <a:stretch/>
        </p:blipFill>
        <p:spPr>
          <a:xfrm>
            <a:off x="3531368" y="4519967"/>
            <a:ext cx="1918127" cy="984985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5782576" y="4203715"/>
          <a:ext cx="2866087" cy="19900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7" r:id="rId7" imgW="3594875" imgH="2495127" progId="Prism7.Document">
                  <p:embed/>
                </p:oleObj>
              </mc:Choice>
              <mc:Fallback>
                <p:oleObj name="Prism 7" r:id="rId7" imgW="3594875" imgH="2495127" progId="Prism7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782576" y="4203715"/>
                        <a:ext cx="2866087" cy="19900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635162" y="525012"/>
            <a:ext cx="1258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rasti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16 h)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644428" y="512957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RSL-3 (8 h)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393152" y="512957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admium (8 h)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78041" y="5834837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. Fig. 9. Renner </a:t>
            </a:r>
            <a:r>
              <a:rPr lang="de-DE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de-DE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4002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7</Words>
  <Application>Microsoft Office PowerPoint</Application>
  <PresentationFormat>Widescreen</PresentationFormat>
  <Paragraphs>45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rism 9</vt:lpstr>
      <vt:lpstr>Prism 5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ochschule Albstadt-Sigmar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ildknecht, Stefan</dc:creator>
  <cp:lastModifiedBy>Schildknecht, Stefan</cp:lastModifiedBy>
  <cp:revision>1</cp:revision>
  <dcterms:created xsi:type="dcterms:W3CDTF">2024-03-17T23:31:23Z</dcterms:created>
  <dcterms:modified xsi:type="dcterms:W3CDTF">2024-03-17T23:31:48Z</dcterms:modified>
</cp:coreProperties>
</file>